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5" r:id="rId3"/>
    <p:sldId id="267" r:id="rId4"/>
    <p:sldId id="268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3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869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9899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532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21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743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157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7054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383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375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744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622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78672-FAA9-4D64-8E1A-5BDD5BF60EB9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8E3AB-F004-4039-B1E1-D25B564671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5475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00" y="1878347"/>
            <a:ext cx="4956769" cy="337478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4491" y="165848"/>
            <a:ext cx="495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526052" y="2086314"/>
          <a:ext cx="4956765" cy="370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50615">
                  <a:extLst>
                    <a:ext uri="{9D8B030D-6E8A-4147-A177-3AD203B41FA5}">
                      <a16:colId xmlns:a16="http://schemas.microsoft.com/office/drawing/2014/main" val="2442975249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2888217988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355019438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1601194894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1007094710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3015863076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2940886678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7457340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1103516923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1510551111"/>
                    </a:ext>
                  </a:extLst>
                </a:gridCol>
                <a:gridCol w="450615">
                  <a:extLst>
                    <a:ext uri="{9D8B030D-6E8A-4147-A177-3AD203B41FA5}">
                      <a16:colId xmlns:a16="http://schemas.microsoft.com/office/drawing/2014/main" val="51226316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4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296794"/>
                  </a:ext>
                </a:extLst>
              </a:tr>
            </a:tbl>
          </a:graphicData>
        </a:graphic>
      </p:graphicFrame>
      <p:cxnSp>
        <p:nvCxnSpPr>
          <p:cNvPr id="8" name="Straight Arrow Connector 7"/>
          <p:cNvCxnSpPr/>
          <p:nvPr/>
        </p:nvCxnSpPr>
        <p:spPr>
          <a:xfrm>
            <a:off x="5482816" y="3679821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694475" y="3499038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95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482816" y="4054834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694475" y="3874051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5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823914" y="2890927"/>
            <a:ext cx="900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823914" y="2890927"/>
            <a:ext cx="0" cy="10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667318" y="2737038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90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4816326" y="4262915"/>
            <a:ext cx="0" cy="57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4834816" y="4834433"/>
            <a:ext cx="900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667318" y="4675542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05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54491" y="5759278"/>
            <a:ext cx="6539163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upplementary figure 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F1</a:t>
            </a: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: 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garose gel electrophoresis of ampliﬁed PCR products upon </a:t>
            </a:r>
            <a:r>
              <a:rPr kumimoji="0" lang="en-US" sz="16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aqI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digestion.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utation at restriction site 731236 causes T to C transformation yielding another restriction site. Homozygous (Hz) wild type (TT) having one restriction at both alleles created only 495 and 245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bands (Lane 4, 7-9 and 11). Heterozygous (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t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) mutant (TC) created 4 bands (495, 290, 245 and 205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) indicating one restriction site at one allele and two restriction sites at another allele (Lane 1,2,5,10). Hz mutant (CC) created 290, 245 and 205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fragments indicating two restriction sites at both alleles (Lane 3). A 100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DNA ladder was used to compare the size of DNA bands as shown in Lane 10. Digested product was resolved in 2% agarose gel. after ethidium bromide staining. Picture was taken using a UV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ransilluminator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.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10454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74" y="1329505"/>
            <a:ext cx="5704264" cy="3379080"/>
          </a:xfrm>
          <a:prstGeom prst="rect">
            <a:avLst/>
          </a:prstGeom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108427" y="1714729"/>
          <a:ext cx="5704265" cy="370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35545">
                  <a:extLst>
                    <a:ext uri="{9D8B030D-6E8A-4147-A177-3AD203B41FA5}">
                      <a16:colId xmlns:a16="http://schemas.microsoft.com/office/drawing/2014/main" val="1910033146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3835071705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813155654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403883259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040331958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714712147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1301498971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856734987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1429347965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337662040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4009060247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568484863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89964952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463403525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2584785966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1503582538"/>
                    </a:ext>
                  </a:extLst>
                </a:gridCol>
                <a:gridCol w="335545">
                  <a:extLst>
                    <a:ext uri="{9D8B030D-6E8A-4147-A177-3AD203B41FA5}">
                      <a16:colId xmlns:a16="http://schemas.microsoft.com/office/drawing/2014/main" val="353246782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3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5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6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8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GB" sz="1200" b="1" dirty="0">
                        <a:solidFill>
                          <a:srgbClr val="FFFF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3787590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080667" y="2413906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822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4968352" y="3230005"/>
            <a:ext cx="11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080666" y="3064789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46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655671" y="3868296"/>
            <a:ext cx="1404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022093" y="3701001"/>
            <a:ext cx="778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76 </a:t>
            </a:r>
            <a:r>
              <a:rPr kumimoji="0" lang="en-GB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5788326" y="2593527"/>
            <a:ext cx="324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960471" y="2834429"/>
            <a:ext cx="0" cy="39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655671" y="3487578"/>
            <a:ext cx="0" cy="39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08426" y="4949587"/>
            <a:ext cx="6565089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F2</a:t>
            </a: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: 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garose gel electrophoresis of ampliﬁed PCR products upon </a:t>
            </a:r>
            <a:r>
              <a:rPr kumimoji="0" lang="en-US" sz="16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smI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digestion.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Mutation at restriction site 1544410 causes C to T transformation yielding no restriction site. Homozygous wild type (CC) having one restriction site at both alleles created only 646 and 176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 bands (not shown).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eterozygous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Ht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 mutant (CT) created 3 bands (822, 646 and 176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bp.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) indicating a restriction site at one allele (Lane 4,11,13-14). Hz mutant (TT) created 822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 fragment indicating no restriction site at both alleles (Lane 1-2,6,10,12,16-17).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 100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bp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DNA ladder was used to compare the size of DNA bands as shown in Lane 8. Digested product was resolved in 2% agarose gel. after ethidium bromide staining. Picture was taken using a UV 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ransilluminator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.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556131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93077" y="109541"/>
            <a:ext cx="6046339" cy="6701529"/>
            <a:chOff x="293077" y="109541"/>
            <a:chExt cx="6046339" cy="6701529"/>
          </a:xfrm>
        </p:grpSpPr>
        <p:sp>
          <p:nvSpPr>
            <p:cNvPr id="2" name="Rectangle 6"/>
            <p:cNvSpPr>
              <a:spLocks noChangeAspect="1" noChangeArrowheads="1"/>
            </p:cNvSpPr>
            <p:nvPr/>
          </p:nvSpPr>
          <p:spPr bwMode="auto">
            <a:xfrm>
              <a:off x="363416" y="1277817"/>
              <a:ext cx="2988000" cy="22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" name="Rectangle 12"/>
            <p:cNvSpPr>
              <a:spLocks noChangeAspect="1" noChangeArrowheads="1"/>
            </p:cNvSpPr>
            <p:nvPr/>
          </p:nvSpPr>
          <p:spPr bwMode="auto">
            <a:xfrm>
              <a:off x="293077" y="128955"/>
              <a:ext cx="2988000" cy="22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6" name="Picture 48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416" y="128955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49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416" y="2380369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5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3785" y="4579070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4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0893" y="109541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4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51047" y="2360955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47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1416" y="4565185"/>
              <a:ext cx="2988000" cy="223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" name="Rectangle 7"/>
          <p:cNvSpPr/>
          <p:nvPr/>
        </p:nvSpPr>
        <p:spPr>
          <a:xfrm>
            <a:off x="42612" y="6943876"/>
            <a:ext cx="665402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SF3: </a:t>
            </a: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alysis of systolic blood pressure and diastolic blood pressure level among VDR genotypes in hypertensive subjects by using One-way ANOVA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 &lt;0.05 was considered as level of signiﬁcance.</a:t>
            </a:r>
          </a:p>
        </p:txBody>
      </p:sp>
    </p:spTree>
    <p:extLst>
      <p:ext uri="{BB962C8B-B14F-4D97-AF65-F5344CB8AC3E}">
        <p14:creationId xmlns:p14="http://schemas.microsoft.com/office/powerpoint/2010/main" val="39360903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9782" y="7498927"/>
            <a:ext cx="645255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200"/>
              </a:spcBef>
              <a:spcAft>
                <a:spcPts val="200"/>
              </a:spcAft>
            </a:pPr>
            <a:r>
              <a:rPr lang="en-GB" b="1" dirty="0" smtClean="0"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Supplementary figure SF4: 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Analysis of vitamin D level among VDR genotypes in hypertensive subjects by using One-way ANOVA.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Vrinda"/>
              </a:rPr>
              <a:t> P &lt;0.05 was considered as level of signiﬁcance.</a:t>
            </a:r>
            <a:endParaRPr lang="en-GB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Vrinda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621765" y="138023"/>
            <a:ext cx="3200400" cy="7132320"/>
            <a:chOff x="862641" y="0"/>
            <a:chExt cx="3200400" cy="7132320"/>
          </a:xfrm>
        </p:grpSpPr>
        <p:graphicFrame>
          <p:nvGraphicFramePr>
            <p:cNvPr id="3" name="Objec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42335476"/>
                </p:ext>
              </p:extLst>
            </p:nvPr>
          </p:nvGraphicFramePr>
          <p:xfrm>
            <a:off x="862641" y="0"/>
            <a:ext cx="3200400" cy="23774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4" name="Prism 5" r:id="rId3" imgW="4201920" imgH="2880360" progId="Prism5.Document">
                    <p:embed/>
                  </p:oleObj>
                </mc:Choice>
                <mc:Fallback>
                  <p:oleObj name="Prism 5" r:id="rId3" imgW="4201920" imgH="2880360" progId="Prism5.Document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62641" y="0"/>
                          <a:ext cx="3200400" cy="23774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62577201"/>
                </p:ext>
              </p:extLst>
            </p:nvPr>
          </p:nvGraphicFramePr>
          <p:xfrm>
            <a:off x="862641" y="2377440"/>
            <a:ext cx="3200400" cy="23774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Prism 5" r:id="rId5" imgW="4192560" imgH="2880360" progId="Prism5.Document">
                    <p:embed/>
                  </p:oleObj>
                </mc:Choice>
                <mc:Fallback>
                  <p:oleObj name="Prism 5" r:id="rId5" imgW="4192560" imgH="2880360" progId="Prism5.Document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62641" y="2377440"/>
                          <a:ext cx="3200400" cy="23774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0216672"/>
                </p:ext>
              </p:extLst>
            </p:nvPr>
          </p:nvGraphicFramePr>
          <p:xfrm>
            <a:off x="862641" y="4754880"/>
            <a:ext cx="3200400" cy="23774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6" name="Prism 5" r:id="rId7" imgW="4082760" imgH="2852640" progId="Prism5.Document">
                    <p:embed/>
                  </p:oleObj>
                </mc:Choice>
                <mc:Fallback>
                  <p:oleObj name="Prism 5" r:id="rId7" imgW="4082760" imgH="2852640" progId="Prism5.Document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62641" y="4754880"/>
                          <a:ext cx="3200400" cy="23774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363882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5</TotalTime>
  <Words>425</Words>
  <Application>Microsoft Office PowerPoint</Application>
  <PresentationFormat>A4 Paper (210x297 mm)</PresentationFormat>
  <Paragraphs>4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Vrinda</vt:lpstr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imam Mahmud</dc:creator>
  <cp:lastModifiedBy>Zimam Mahmud</cp:lastModifiedBy>
  <cp:revision>44</cp:revision>
  <dcterms:created xsi:type="dcterms:W3CDTF">2022-08-23T11:53:37Z</dcterms:created>
  <dcterms:modified xsi:type="dcterms:W3CDTF">2024-02-15T17:13:59Z</dcterms:modified>
</cp:coreProperties>
</file>